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D83046-6172-41D8-A1C4-AEBE19A6C96C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C9F47E-F747-4180-B8AB-E8A629A4BF0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3520D5-3E33-4496-BF5F-454D2A2E85F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B96259-727B-4B10-AA83-2CE493C86396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E05D2-D2FF-43EE-883E-B0860E5B1D7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29"/>
          <p:cNvGrpSpPr/>
          <p:nvPr/>
        </p:nvGrpSpPr>
        <p:grpSpPr>
          <a:xfrm>
            <a:off x="228600" y="533400"/>
            <a:ext cx="8686800" cy="6152696"/>
            <a:chOff x="76200" y="152400"/>
            <a:chExt cx="8915400" cy="6533696"/>
          </a:xfrm>
        </p:grpSpPr>
        <p:cxnSp>
          <p:nvCxnSpPr>
            <p:cNvPr id="2076" name="Straight Connector 2075"/>
            <p:cNvCxnSpPr/>
            <p:nvPr/>
          </p:nvCxnSpPr>
          <p:spPr>
            <a:xfrm>
              <a:off x="1167793" y="2286000"/>
              <a:ext cx="7669100" cy="1853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6" name="Rectangle 51"/>
            <p:cNvSpPr>
              <a:spLocks noChangeArrowheads="1"/>
            </p:cNvSpPr>
            <p:nvPr/>
          </p:nvSpPr>
          <p:spPr bwMode="auto">
            <a:xfrm>
              <a:off x="1524000" y="609600"/>
              <a:ext cx="345447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dsorbed/Eluted   DQA1*02:01/DQB1*04:01 cells</a:t>
              </a:r>
              <a:endPara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Freeform 8"/>
            <p:cNvSpPr>
              <a:spLocks noEditPoints="1"/>
            </p:cNvSpPr>
            <p:nvPr/>
          </p:nvSpPr>
          <p:spPr bwMode="auto">
            <a:xfrm>
              <a:off x="1210681" y="542422"/>
              <a:ext cx="7626212" cy="1564282"/>
            </a:xfrm>
            <a:custGeom>
              <a:avLst/>
              <a:gdLst>
                <a:gd name="T0" fmla="*/ 0 w 9916"/>
                <a:gd name="T1" fmla="*/ 1700 h 1705"/>
                <a:gd name="T2" fmla="*/ 9916 w 9916"/>
                <a:gd name="T3" fmla="*/ 1700 h 1705"/>
                <a:gd name="T4" fmla="*/ 9916 w 9916"/>
                <a:gd name="T5" fmla="*/ 1705 h 1705"/>
                <a:gd name="T6" fmla="*/ 0 w 9916"/>
                <a:gd name="T7" fmla="*/ 1705 h 1705"/>
                <a:gd name="T8" fmla="*/ 0 w 9916"/>
                <a:gd name="T9" fmla="*/ 1700 h 1705"/>
                <a:gd name="T10" fmla="*/ 0 w 9916"/>
                <a:gd name="T11" fmla="*/ 1416 h 1705"/>
                <a:gd name="T12" fmla="*/ 9916 w 9916"/>
                <a:gd name="T13" fmla="*/ 1416 h 1705"/>
                <a:gd name="T14" fmla="*/ 9916 w 9916"/>
                <a:gd name="T15" fmla="*/ 1422 h 1705"/>
                <a:gd name="T16" fmla="*/ 0 w 9916"/>
                <a:gd name="T17" fmla="*/ 1422 h 1705"/>
                <a:gd name="T18" fmla="*/ 0 w 9916"/>
                <a:gd name="T19" fmla="*/ 1416 h 1705"/>
                <a:gd name="T20" fmla="*/ 0 w 9916"/>
                <a:gd name="T21" fmla="*/ 1133 h 1705"/>
                <a:gd name="T22" fmla="*/ 9916 w 9916"/>
                <a:gd name="T23" fmla="*/ 1133 h 1705"/>
                <a:gd name="T24" fmla="*/ 9916 w 9916"/>
                <a:gd name="T25" fmla="*/ 1139 h 1705"/>
                <a:gd name="T26" fmla="*/ 0 w 9916"/>
                <a:gd name="T27" fmla="*/ 1139 h 1705"/>
                <a:gd name="T28" fmla="*/ 0 w 9916"/>
                <a:gd name="T29" fmla="*/ 1133 h 1705"/>
                <a:gd name="T30" fmla="*/ 0 w 9916"/>
                <a:gd name="T31" fmla="*/ 850 h 1705"/>
                <a:gd name="T32" fmla="*/ 9916 w 9916"/>
                <a:gd name="T33" fmla="*/ 850 h 1705"/>
                <a:gd name="T34" fmla="*/ 9916 w 9916"/>
                <a:gd name="T35" fmla="*/ 856 h 1705"/>
                <a:gd name="T36" fmla="*/ 0 w 9916"/>
                <a:gd name="T37" fmla="*/ 856 h 1705"/>
                <a:gd name="T38" fmla="*/ 0 w 9916"/>
                <a:gd name="T39" fmla="*/ 850 h 1705"/>
                <a:gd name="T40" fmla="*/ 0 w 9916"/>
                <a:gd name="T41" fmla="*/ 567 h 1705"/>
                <a:gd name="T42" fmla="*/ 9916 w 9916"/>
                <a:gd name="T43" fmla="*/ 567 h 1705"/>
                <a:gd name="T44" fmla="*/ 9916 w 9916"/>
                <a:gd name="T45" fmla="*/ 573 h 1705"/>
                <a:gd name="T46" fmla="*/ 0 w 9916"/>
                <a:gd name="T47" fmla="*/ 573 h 1705"/>
                <a:gd name="T48" fmla="*/ 0 w 9916"/>
                <a:gd name="T49" fmla="*/ 567 h 1705"/>
                <a:gd name="T50" fmla="*/ 0 w 9916"/>
                <a:gd name="T51" fmla="*/ 284 h 1705"/>
                <a:gd name="T52" fmla="*/ 9916 w 9916"/>
                <a:gd name="T53" fmla="*/ 284 h 1705"/>
                <a:gd name="T54" fmla="*/ 9916 w 9916"/>
                <a:gd name="T55" fmla="*/ 289 h 1705"/>
                <a:gd name="T56" fmla="*/ 0 w 9916"/>
                <a:gd name="T57" fmla="*/ 289 h 1705"/>
                <a:gd name="T58" fmla="*/ 0 w 9916"/>
                <a:gd name="T59" fmla="*/ 284 h 1705"/>
                <a:gd name="T60" fmla="*/ 0 w 9916"/>
                <a:gd name="T61" fmla="*/ 0 h 1705"/>
                <a:gd name="T62" fmla="*/ 9916 w 9916"/>
                <a:gd name="T63" fmla="*/ 0 h 1705"/>
                <a:gd name="T64" fmla="*/ 9916 w 9916"/>
                <a:gd name="T65" fmla="*/ 6 h 1705"/>
                <a:gd name="T66" fmla="*/ 0 w 9916"/>
                <a:gd name="T67" fmla="*/ 6 h 1705"/>
                <a:gd name="T68" fmla="*/ 0 w 9916"/>
                <a:gd name="T69" fmla="*/ 0 h 17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9916" h="1705">
                  <a:moveTo>
                    <a:pt x="0" y="1700"/>
                  </a:moveTo>
                  <a:lnTo>
                    <a:pt x="9916" y="1700"/>
                  </a:lnTo>
                  <a:lnTo>
                    <a:pt x="9916" y="1705"/>
                  </a:lnTo>
                  <a:lnTo>
                    <a:pt x="0" y="1705"/>
                  </a:lnTo>
                  <a:lnTo>
                    <a:pt x="0" y="1700"/>
                  </a:lnTo>
                  <a:close/>
                  <a:moveTo>
                    <a:pt x="0" y="1416"/>
                  </a:moveTo>
                  <a:lnTo>
                    <a:pt x="9916" y="1416"/>
                  </a:lnTo>
                  <a:lnTo>
                    <a:pt x="9916" y="1422"/>
                  </a:lnTo>
                  <a:lnTo>
                    <a:pt x="0" y="1422"/>
                  </a:lnTo>
                  <a:lnTo>
                    <a:pt x="0" y="1416"/>
                  </a:lnTo>
                  <a:close/>
                  <a:moveTo>
                    <a:pt x="0" y="1133"/>
                  </a:moveTo>
                  <a:lnTo>
                    <a:pt x="9916" y="1133"/>
                  </a:lnTo>
                  <a:lnTo>
                    <a:pt x="9916" y="1139"/>
                  </a:lnTo>
                  <a:lnTo>
                    <a:pt x="0" y="1139"/>
                  </a:lnTo>
                  <a:lnTo>
                    <a:pt x="0" y="1133"/>
                  </a:lnTo>
                  <a:close/>
                  <a:moveTo>
                    <a:pt x="0" y="850"/>
                  </a:moveTo>
                  <a:lnTo>
                    <a:pt x="9916" y="850"/>
                  </a:lnTo>
                  <a:lnTo>
                    <a:pt x="9916" y="856"/>
                  </a:lnTo>
                  <a:lnTo>
                    <a:pt x="0" y="856"/>
                  </a:lnTo>
                  <a:lnTo>
                    <a:pt x="0" y="850"/>
                  </a:lnTo>
                  <a:close/>
                  <a:moveTo>
                    <a:pt x="0" y="567"/>
                  </a:moveTo>
                  <a:lnTo>
                    <a:pt x="9916" y="567"/>
                  </a:lnTo>
                  <a:lnTo>
                    <a:pt x="9916" y="573"/>
                  </a:lnTo>
                  <a:lnTo>
                    <a:pt x="0" y="573"/>
                  </a:lnTo>
                  <a:lnTo>
                    <a:pt x="0" y="567"/>
                  </a:lnTo>
                  <a:close/>
                  <a:moveTo>
                    <a:pt x="0" y="284"/>
                  </a:moveTo>
                  <a:lnTo>
                    <a:pt x="9916" y="284"/>
                  </a:lnTo>
                  <a:lnTo>
                    <a:pt x="9916" y="289"/>
                  </a:lnTo>
                  <a:lnTo>
                    <a:pt x="0" y="289"/>
                  </a:lnTo>
                  <a:lnTo>
                    <a:pt x="0" y="284"/>
                  </a:lnTo>
                  <a:close/>
                  <a:moveTo>
                    <a:pt x="0" y="0"/>
                  </a:moveTo>
                  <a:lnTo>
                    <a:pt x="9916" y="0"/>
                  </a:lnTo>
                  <a:lnTo>
                    <a:pt x="991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Freeform 9"/>
            <p:cNvSpPr>
              <a:spLocks noEditPoints="1"/>
            </p:cNvSpPr>
            <p:nvPr/>
          </p:nvSpPr>
          <p:spPr bwMode="auto">
            <a:xfrm>
              <a:off x="1289895" y="827754"/>
              <a:ext cx="7468550" cy="1536758"/>
            </a:xfrm>
            <a:custGeom>
              <a:avLst/>
              <a:gdLst>
                <a:gd name="T0" fmla="*/ 136 w 9711"/>
                <a:gd name="T1" fmla="*/ 1675 h 1675"/>
                <a:gd name="T2" fmla="*/ 342 w 9711"/>
                <a:gd name="T3" fmla="*/ 1667 h 1675"/>
                <a:gd name="T4" fmla="*/ 342 w 9711"/>
                <a:gd name="T5" fmla="*/ 1675 h 1675"/>
                <a:gd name="T6" fmla="*/ 821 w 9711"/>
                <a:gd name="T7" fmla="*/ 1666 h 1675"/>
                <a:gd name="T8" fmla="*/ 684 w 9711"/>
                <a:gd name="T9" fmla="*/ 1666 h 1675"/>
                <a:gd name="T10" fmla="*/ 1163 w 9711"/>
                <a:gd name="T11" fmla="*/ 1675 h 1675"/>
                <a:gd name="T12" fmla="*/ 1367 w 9711"/>
                <a:gd name="T13" fmla="*/ 1673 h 1675"/>
                <a:gd name="T14" fmla="*/ 1367 w 9711"/>
                <a:gd name="T15" fmla="*/ 1675 h 1675"/>
                <a:gd name="T16" fmla="*/ 1846 w 9711"/>
                <a:gd name="T17" fmla="*/ 201 h 1675"/>
                <a:gd name="T18" fmla="*/ 1710 w 9711"/>
                <a:gd name="T19" fmla="*/ 201 h 1675"/>
                <a:gd name="T20" fmla="*/ 2188 w 9711"/>
                <a:gd name="T21" fmla="*/ 1675 h 1675"/>
                <a:gd name="T22" fmla="*/ 2393 w 9711"/>
                <a:gd name="T23" fmla="*/ 370 h 1675"/>
                <a:gd name="T24" fmla="*/ 2393 w 9711"/>
                <a:gd name="T25" fmla="*/ 1675 h 1675"/>
                <a:gd name="T26" fmla="*/ 2872 w 9711"/>
                <a:gd name="T27" fmla="*/ 470 h 1675"/>
                <a:gd name="T28" fmla="*/ 2735 w 9711"/>
                <a:gd name="T29" fmla="*/ 470 h 1675"/>
                <a:gd name="T30" fmla="*/ 3214 w 9711"/>
                <a:gd name="T31" fmla="*/ 1675 h 1675"/>
                <a:gd name="T32" fmla="*/ 3420 w 9711"/>
                <a:gd name="T33" fmla="*/ 84 h 1675"/>
                <a:gd name="T34" fmla="*/ 3420 w 9711"/>
                <a:gd name="T35" fmla="*/ 1675 h 1675"/>
                <a:gd name="T36" fmla="*/ 3898 w 9711"/>
                <a:gd name="T37" fmla="*/ 191 h 1675"/>
                <a:gd name="T38" fmla="*/ 3761 w 9711"/>
                <a:gd name="T39" fmla="*/ 191 h 1675"/>
                <a:gd name="T40" fmla="*/ 4239 w 9711"/>
                <a:gd name="T41" fmla="*/ 1675 h 1675"/>
                <a:gd name="T42" fmla="*/ 4445 w 9711"/>
                <a:gd name="T43" fmla="*/ 379 h 1675"/>
                <a:gd name="T44" fmla="*/ 4445 w 9711"/>
                <a:gd name="T45" fmla="*/ 1675 h 1675"/>
                <a:gd name="T46" fmla="*/ 4924 w 9711"/>
                <a:gd name="T47" fmla="*/ 67 h 1675"/>
                <a:gd name="T48" fmla="*/ 4787 w 9711"/>
                <a:gd name="T49" fmla="*/ 67 h 1675"/>
                <a:gd name="T50" fmla="*/ 5266 w 9711"/>
                <a:gd name="T51" fmla="*/ 1675 h 1675"/>
                <a:gd name="T52" fmla="*/ 5471 w 9711"/>
                <a:gd name="T53" fmla="*/ 16 h 1675"/>
                <a:gd name="T54" fmla="*/ 5471 w 9711"/>
                <a:gd name="T55" fmla="*/ 1675 h 1675"/>
                <a:gd name="T56" fmla="*/ 5949 w 9711"/>
                <a:gd name="T57" fmla="*/ 1665 h 1675"/>
                <a:gd name="T58" fmla="*/ 5813 w 9711"/>
                <a:gd name="T59" fmla="*/ 1665 h 1675"/>
                <a:gd name="T60" fmla="*/ 6292 w 9711"/>
                <a:gd name="T61" fmla="*/ 1675 h 1675"/>
                <a:gd name="T62" fmla="*/ 6496 w 9711"/>
                <a:gd name="T63" fmla="*/ 1661 h 1675"/>
                <a:gd name="T64" fmla="*/ 6496 w 9711"/>
                <a:gd name="T65" fmla="*/ 1675 h 1675"/>
                <a:gd name="T66" fmla="*/ 6975 w 9711"/>
                <a:gd name="T67" fmla="*/ 1673 h 1675"/>
                <a:gd name="T68" fmla="*/ 6838 w 9711"/>
                <a:gd name="T69" fmla="*/ 1673 h 1675"/>
                <a:gd name="T70" fmla="*/ 7317 w 9711"/>
                <a:gd name="T71" fmla="*/ 1675 h 1675"/>
                <a:gd name="T72" fmla="*/ 7523 w 9711"/>
                <a:gd name="T73" fmla="*/ 44 h 1675"/>
                <a:gd name="T74" fmla="*/ 7523 w 9711"/>
                <a:gd name="T75" fmla="*/ 1675 h 1675"/>
                <a:gd name="T76" fmla="*/ 8001 w 9711"/>
                <a:gd name="T77" fmla="*/ 479 h 1675"/>
                <a:gd name="T78" fmla="*/ 7864 w 9711"/>
                <a:gd name="T79" fmla="*/ 479 h 1675"/>
                <a:gd name="T80" fmla="*/ 8343 w 9711"/>
                <a:gd name="T81" fmla="*/ 1675 h 1675"/>
                <a:gd name="T82" fmla="*/ 8548 w 9711"/>
                <a:gd name="T83" fmla="*/ 661 h 1675"/>
                <a:gd name="T84" fmla="*/ 8548 w 9711"/>
                <a:gd name="T85" fmla="*/ 1675 h 1675"/>
                <a:gd name="T86" fmla="*/ 9027 w 9711"/>
                <a:gd name="T87" fmla="*/ 16 h 1675"/>
                <a:gd name="T88" fmla="*/ 8891 w 9711"/>
                <a:gd name="T89" fmla="*/ 16 h 1675"/>
                <a:gd name="T90" fmla="*/ 9369 w 9711"/>
                <a:gd name="T91" fmla="*/ 1675 h 1675"/>
                <a:gd name="T92" fmla="*/ 9574 w 9711"/>
                <a:gd name="T93" fmla="*/ 500 h 1675"/>
                <a:gd name="T94" fmla="*/ 9574 w 9711"/>
                <a:gd name="T95" fmla="*/ 1675 h 16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9711" h="1675">
                  <a:moveTo>
                    <a:pt x="0" y="1669"/>
                  </a:moveTo>
                  <a:lnTo>
                    <a:pt x="136" y="1669"/>
                  </a:lnTo>
                  <a:lnTo>
                    <a:pt x="136" y="1675"/>
                  </a:lnTo>
                  <a:lnTo>
                    <a:pt x="0" y="1675"/>
                  </a:lnTo>
                  <a:lnTo>
                    <a:pt x="0" y="1669"/>
                  </a:lnTo>
                  <a:close/>
                  <a:moveTo>
                    <a:pt x="342" y="1667"/>
                  </a:moveTo>
                  <a:lnTo>
                    <a:pt x="478" y="1667"/>
                  </a:lnTo>
                  <a:lnTo>
                    <a:pt x="478" y="1675"/>
                  </a:lnTo>
                  <a:lnTo>
                    <a:pt x="342" y="1675"/>
                  </a:lnTo>
                  <a:lnTo>
                    <a:pt x="342" y="1667"/>
                  </a:lnTo>
                  <a:close/>
                  <a:moveTo>
                    <a:pt x="684" y="1666"/>
                  </a:moveTo>
                  <a:lnTo>
                    <a:pt x="821" y="1666"/>
                  </a:lnTo>
                  <a:lnTo>
                    <a:pt x="821" y="1675"/>
                  </a:lnTo>
                  <a:lnTo>
                    <a:pt x="684" y="1675"/>
                  </a:lnTo>
                  <a:lnTo>
                    <a:pt x="684" y="1666"/>
                  </a:lnTo>
                  <a:close/>
                  <a:moveTo>
                    <a:pt x="1025" y="1671"/>
                  </a:moveTo>
                  <a:lnTo>
                    <a:pt x="1163" y="1671"/>
                  </a:lnTo>
                  <a:lnTo>
                    <a:pt x="1163" y="1675"/>
                  </a:lnTo>
                  <a:lnTo>
                    <a:pt x="1025" y="1675"/>
                  </a:lnTo>
                  <a:lnTo>
                    <a:pt x="1025" y="1671"/>
                  </a:lnTo>
                  <a:close/>
                  <a:moveTo>
                    <a:pt x="1367" y="1673"/>
                  </a:moveTo>
                  <a:lnTo>
                    <a:pt x="1504" y="1673"/>
                  </a:lnTo>
                  <a:lnTo>
                    <a:pt x="1504" y="1675"/>
                  </a:lnTo>
                  <a:lnTo>
                    <a:pt x="1367" y="1675"/>
                  </a:lnTo>
                  <a:lnTo>
                    <a:pt x="1367" y="1673"/>
                  </a:lnTo>
                  <a:close/>
                  <a:moveTo>
                    <a:pt x="1710" y="201"/>
                  </a:moveTo>
                  <a:lnTo>
                    <a:pt x="1846" y="201"/>
                  </a:lnTo>
                  <a:lnTo>
                    <a:pt x="1846" y="1675"/>
                  </a:lnTo>
                  <a:lnTo>
                    <a:pt x="1710" y="1675"/>
                  </a:lnTo>
                  <a:lnTo>
                    <a:pt x="1710" y="201"/>
                  </a:lnTo>
                  <a:close/>
                  <a:moveTo>
                    <a:pt x="2052" y="70"/>
                  </a:moveTo>
                  <a:lnTo>
                    <a:pt x="2188" y="70"/>
                  </a:lnTo>
                  <a:lnTo>
                    <a:pt x="2188" y="1675"/>
                  </a:lnTo>
                  <a:lnTo>
                    <a:pt x="2052" y="1675"/>
                  </a:lnTo>
                  <a:lnTo>
                    <a:pt x="2052" y="70"/>
                  </a:lnTo>
                  <a:close/>
                  <a:moveTo>
                    <a:pt x="2393" y="370"/>
                  </a:moveTo>
                  <a:lnTo>
                    <a:pt x="2530" y="370"/>
                  </a:lnTo>
                  <a:lnTo>
                    <a:pt x="2530" y="1675"/>
                  </a:lnTo>
                  <a:lnTo>
                    <a:pt x="2393" y="1675"/>
                  </a:lnTo>
                  <a:lnTo>
                    <a:pt x="2393" y="370"/>
                  </a:lnTo>
                  <a:close/>
                  <a:moveTo>
                    <a:pt x="2735" y="470"/>
                  </a:moveTo>
                  <a:lnTo>
                    <a:pt x="2872" y="470"/>
                  </a:lnTo>
                  <a:lnTo>
                    <a:pt x="2872" y="1675"/>
                  </a:lnTo>
                  <a:lnTo>
                    <a:pt x="2735" y="1675"/>
                  </a:lnTo>
                  <a:lnTo>
                    <a:pt x="2735" y="470"/>
                  </a:lnTo>
                  <a:close/>
                  <a:moveTo>
                    <a:pt x="3077" y="248"/>
                  </a:moveTo>
                  <a:lnTo>
                    <a:pt x="3214" y="248"/>
                  </a:lnTo>
                  <a:lnTo>
                    <a:pt x="3214" y="1675"/>
                  </a:lnTo>
                  <a:lnTo>
                    <a:pt x="3077" y="1675"/>
                  </a:lnTo>
                  <a:lnTo>
                    <a:pt x="3077" y="248"/>
                  </a:lnTo>
                  <a:close/>
                  <a:moveTo>
                    <a:pt x="3420" y="84"/>
                  </a:moveTo>
                  <a:lnTo>
                    <a:pt x="3556" y="84"/>
                  </a:lnTo>
                  <a:lnTo>
                    <a:pt x="3556" y="1675"/>
                  </a:lnTo>
                  <a:lnTo>
                    <a:pt x="3420" y="1675"/>
                  </a:lnTo>
                  <a:lnTo>
                    <a:pt x="3420" y="84"/>
                  </a:lnTo>
                  <a:close/>
                  <a:moveTo>
                    <a:pt x="3761" y="191"/>
                  </a:moveTo>
                  <a:lnTo>
                    <a:pt x="3898" y="191"/>
                  </a:lnTo>
                  <a:lnTo>
                    <a:pt x="3898" y="1675"/>
                  </a:lnTo>
                  <a:lnTo>
                    <a:pt x="3761" y="1675"/>
                  </a:lnTo>
                  <a:lnTo>
                    <a:pt x="3761" y="191"/>
                  </a:lnTo>
                  <a:close/>
                  <a:moveTo>
                    <a:pt x="4103" y="348"/>
                  </a:moveTo>
                  <a:lnTo>
                    <a:pt x="4239" y="348"/>
                  </a:lnTo>
                  <a:lnTo>
                    <a:pt x="4239" y="1675"/>
                  </a:lnTo>
                  <a:lnTo>
                    <a:pt x="4103" y="1675"/>
                  </a:lnTo>
                  <a:lnTo>
                    <a:pt x="4103" y="348"/>
                  </a:lnTo>
                  <a:close/>
                  <a:moveTo>
                    <a:pt x="4445" y="379"/>
                  </a:moveTo>
                  <a:lnTo>
                    <a:pt x="4582" y="379"/>
                  </a:lnTo>
                  <a:lnTo>
                    <a:pt x="4582" y="1675"/>
                  </a:lnTo>
                  <a:lnTo>
                    <a:pt x="4445" y="1675"/>
                  </a:lnTo>
                  <a:lnTo>
                    <a:pt x="4445" y="379"/>
                  </a:lnTo>
                  <a:close/>
                  <a:moveTo>
                    <a:pt x="4787" y="67"/>
                  </a:moveTo>
                  <a:lnTo>
                    <a:pt x="4924" y="67"/>
                  </a:lnTo>
                  <a:lnTo>
                    <a:pt x="4924" y="1675"/>
                  </a:lnTo>
                  <a:lnTo>
                    <a:pt x="4787" y="1675"/>
                  </a:lnTo>
                  <a:lnTo>
                    <a:pt x="4787" y="67"/>
                  </a:lnTo>
                  <a:close/>
                  <a:moveTo>
                    <a:pt x="5128" y="0"/>
                  </a:moveTo>
                  <a:lnTo>
                    <a:pt x="5266" y="0"/>
                  </a:lnTo>
                  <a:lnTo>
                    <a:pt x="5266" y="1675"/>
                  </a:lnTo>
                  <a:lnTo>
                    <a:pt x="5128" y="1675"/>
                  </a:lnTo>
                  <a:lnTo>
                    <a:pt x="5128" y="0"/>
                  </a:lnTo>
                  <a:close/>
                  <a:moveTo>
                    <a:pt x="5471" y="16"/>
                  </a:moveTo>
                  <a:lnTo>
                    <a:pt x="5607" y="16"/>
                  </a:lnTo>
                  <a:lnTo>
                    <a:pt x="5607" y="1675"/>
                  </a:lnTo>
                  <a:lnTo>
                    <a:pt x="5471" y="1675"/>
                  </a:lnTo>
                  <a:lnTo>
                    <a:pt x="5471" y="16"/>
                  </a:lnTo>
                  <a:close/>
                  <a:moveTo>
                    <a:pt x="5813" y="1665"/>
                  </a:moveTo>
                  <a:lnTo>
                    <a:pt x="5949" y="1665"/>
                  </a:lnTo>
                  <a:lnTo>
                    <a:pt x="5949" y="1675"/>
                  </a:lnTo>
                  <a:lnTo>
                    <a:pt x="5813" y="1675"/>
                  </a:lnTo>
                  <a:lnTo>
                    <a:pt x="5813" y="1665"/>
                  </a:lnTo>
                  <a:close/>
                  <a:moveTo>
                    <a:pt x="6155" y="1671"/>
                  </a:moveTo>
                  <a:lnTo>
                    <a:pt x="6292" y="1671"/>
                  </a:lnTo>
                  <a:lnTo>
                    <a:pt x="6292" y="1675"/>
                  </a:lnTo>
                  <a:lnTo>
                    <a:pt x="6155" y="1675"/>
                  </a:lnTo>
                  <a:lnTo>
                    <a:pt x="6155" y="1671"/>
                  </a:lnTo>
                  <a:close/>
                  <a:moveTo>
                    <a:pt x="6496" y="1661"/>
                  </a:moveTo>
                  <a:lnTo>
                    <a:pt x="6634" y="1661"/>
                  </a:lnTo>
                  <a:lnTo>
                    <a:pt x="6634" y="1675"/>
                  </a:lnTo>
                  <a:lnTo>
                    <a:pt x="6496" y="1675"/>
                  </a:lnTo>
                  <a:lnTo>
                    <a:pt x="6496" y="1661"/>
                  </a:lnTo>
                  <a:close/>
                  <a:moveTo>
                    <a:pt x="6838" y="1673"/>
                  </a:moveTo>
                  <a:lnTo>
                    <a:pt x="6975" y="1673"/>
                  </a:lnTo>
                  <a:lnTo>
                    <a:pt x="6975" y="1675"/>
                  </a:lnTo>
                  <a:lnTo>
                    <a:pt x="6838" y="1675"/>
                  </a:lnTo>
                  <a:lnTo>
                    <a:pt x="6838" y="1673"/>
                  </a:lnTo>
                  <a:close/>
                  <a:moveTo>
                    <a:pt x="7181" y="1673"/>
                  </a:moveTo>
                  <a:lnTo>
                    <a:pt x="7317" y="1673"/>
                  </a:lnTo>
                  <a:lnTo>
                    <a:pt x="7317" y="1675"/>
                  </a:lnTo>
                  <a:lnTo>
                    <a:pt x="7181" y="1675"/>
                  </a:lnTo>
                  <a:lnTo>
                    <a:pt x="7181" y="1673"/>
                  </a:lnTo>
                  <a:close/>
                  <a:moveTo>
                    <a:pt x="7523" y="44"/>
                  </a:moveTo>
                  <a:lnTo>
                    <a:pt x="7659" y="44"/>
                  </a:lnTo>
                  <a:lnTo>
                    <a:pt x="7659" y="1675"/>
                  </a:lnTo>
                  <a:lnTo>
                    <a:pt x="7523" y="1675"/>
                  </a:lnTo>
                  <a:lnTo>
                    <a:pt x="7523" y="44"/>
                  </a:lnTo>
                  <a:close/>
                  <a:moveTo>
                    <a:pt x="7864" y="479"/>
                  </a:moveTo>
                  <a:lnTo>
                    <a:pt x="8001" y="479"/>
                  </a:lnTo>
                  <a:lnTo>
                    <a:pt x="8001" y="1675"/>
                  </a:lnTo>
                  <a:lnTo>
                    <a:pt x="7864" y="1675"/>
                  </a:lnTo>
                  <a:lnTo>
                    <a:pt x="7864" y="479"/>
                  </a:lnTo>
                  <a:close/>
                  <a:moveTo>
                    <a:pt x="8206" y="601"/>
                  </a:moveTo>
                  <a:lnTo>
                    <a:pt x="8343" y="601"/>
                  </a:lnTo>
                  <a:lnTo>
                    <a:pt x="8343" y="1675"/>
                  </a:lnTo>
                  <a:lnTo>
                    <a:pt x="8206" y="1675"/>
                  </a:lnTo>
                  <a:lnTo>
                    <a:pt x="8206" y="601"/>
                  </a:lnTo>
                  <a:close/>
                  <a:moveTo>
                    <a:pt x="8548" y="661"/>
                  </a:moveTo>
                  <a:lnTo>
                    <a:pt x="8685" y="661"/>
                  </a:lnTo>
                  <a:lnTo>
                    <a:pt x="8685" y="1675"/>
                  </a:lnTo>
                  <a:lnTo>
                    <a:pt x="8548" y="1675"/>
                  </a:lnTo>
                  <a:lnTo>
                    <a:pt x="8548" y="661"/>
                  </a:lnTo>
                  <a:close/>
                  <a:moveTo>
                    <a:pt x="8891" y="16"/>
                  </a:moveTo>
                  <a:lnTo>
                    <a:pt x="9027" y="16"/>
                  </a:lnTo>
                  <a:lnTo>
                    <a:pt x="9027" y="1675"/>
                  </a:lnTo>
                  <a:lnTo>
                    <a:pt x="8891" y="1675"/>
                  </a:lnTo>
                  <a:lnTo>
                    <a:pt x="8891" y="16"/>
                  </a:lnTo>
                  <a:close/>
                  <a:moveTo>
                    <a:pt x="9232" y="85"/>
                  </a:moveTo>
                  <a:lnTo>
                    <a:pt x="9369" y="85"/>
                  </a:lnTo>
                  <a:lnTo>
                    <a:pt x="9369" y="1675"/>
                  </a:lnTo>
                  <a:lnTo>
                    <a:pt x="9232" y="1675"/>
                  </a:lnTo>
                  <a:lnTo>
                    <a:pt x="9232" y="85"/>
                  </a:lnTo>
                  <a:close/>
                  <a:moveTo>
                    <a:pt x="9574" y="500"/>
                  </a:moveTo>
                  <a:lnTo>
                    <a:pt x="9711" y="500"/>
                  </a:lnTo>
                  <a:lnTo>
                    <a:pt x="9711" y="1675"/>
                  </a:lnTo>
                  <a:lnTo>
                    <a:pt x="9574" y="1675"/>
                  </a:lnTo>
                  <a:lnTo>
                    <a:pt x="9574" y="500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1208373" y="545174"/>
              <a:ext cx="4615" cy="18193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11"/>
            <p:cNvSpPr>
              <a:spLocks noEditPoints="1"/>
            </p:cNvSpPr>
            <p:nvPr/>
          </p:nvSpPr>
          <p:spPr bwMode="auto">
            <a:xfrm>
              <a:off x="1181456" y="542422"/>
              <a:ext cx="29225" cy="1823926"/>
            </a:xfrm>
            <a:custGeom>
              <a:avLst/>
              <a:gdLst>
                <a:gd name="T0" fmla="*/ 0 w 38"/>
                <a:gd name="T1" fmla="*/ 1983 h 1988"/>
                <a:gd name="T2" fmla="*/ 38 w 38"/>
                <a:gd name="T3" fmla="*/ 1983 h 1988"/>
                <a:gd name="T4" fmla="*/ 38 w 38"/>
                <a:gd name="T5" fmla="*/ 1988 h 1988"/>
                <a:gd name="T6" fmla="*/ 0 w 38"/>
                <a:gd name="T7" fmla="*/ 1988 h 1988"/>
                <a:gd name="T8" fmla="*/ 0 w 38"/>
                <a:gd name="T9" fmla="*/ 1983 h 1988"/>
                <a:gd name="T10" fmla="*/ 0 w 38"/>
                <a:gd name="T11" fmla="*/ 1700 h 1988"/>
                <a:gd name="T12" fmla="*/ 38 w 38"/>
                <a:gd name="T13" fmla="*/ 1700 h 1988"/>
                <a:gd name="T14" fmla="*/ 38 w 38"/>
                <a:gd name="T15" fmla="*/ 1705 h 1988"/>
                <a:gd name="T16" fmla="*/ 0 w 38"/>
                <a:gd name="T17" fmla="*/ 1705 h 1988"/>
                <a:gd name="T18" fmla="*/ 0 w 38"/>
                <a:gd name="T19" fmla="*/ 1700 h 1988"/>
                <a:gd name="T20" fmla="*/ 0 w 38"/>
                <a:gd name="T21" fmla="*/ 1416 h 1988"/>
                <a:gd name="T22" fmla="*/ 38 w 38"/>
                <a:gd name="T23" fmla="*/ 1416 h 1988"/>
                <a:gd name="T24" fmla="*/ 38 w 38"/>
                <a:gd name="T25" fmla="*/ 1422 h 1988"/>
                <a:gd name="T26" fmla="*/ 0 w 38"/>
                <a:gd name="T27" fmla="*/ 1422 h 1988"/>
                <a:gd name="T28" fmla="*/ 0 w 38"/>
                <a:gd name="T29" fmla="*/ 1416 h 1988"/>
                <a:gd name="T30" fmla="*/ 0 w 38"/>
                <a:gd name="T31" fmla="*/ 1133 h 1988"/>
                <a:gd name="T32" fmla="*/ 38 w 38"/>
                <a:gd name="T33" fmla="*/ 1133 h 1988"/>
                <a:gd name="T34" fmla="*/ 38 w 38"/>
                <a:gd name="T35" fmla="*/ 1139 h 1988"/>
                <a:gd name="T36" fmla="*/ 0 w 38"/>
                <a:gd name="T37" fmla="*/ 1139 h 1988"/>
                <a:gd name="T38" fmla="*/ 0 w 38"/>
                <a:gd name="T39" fmla="*/ 1133 h 1988"/>
                <a:gd name="T40" fmla="*/ 0 w 38"/>
                <a:gd name="T41" fmla="*/ 850 h 1988"/>
                <a:gd name="T42" fmla="*/ 38 w 38"/>
                <a:gd name="T43" fmla="*/ 850 h 1988"/>
                <a:gd name="T44" fmla="*/ 38 w 38"/>
                <a:gd name="T45" fmla="*/ 856 h 1988"/>
                <a:gd name="T46" fmla="*/ 0 w 38"/>
                <a:gd name="T47" fmla="*/ 856 h 1988"/>
                <a:gd name="T48" fmla="*/ 0 w 38"/>
                <a:gd name="T49" fmla="*/ 850 h 1988"/>
                <a:gd name="T50" fmla="*/ 0 w 38"/>
                <a:gd name="T51" fmla="*/ 567 h 1988"/>
                <a:gd name="T52" fmla="*/ 38 w 38"/>
                <a:gd name="T53" fmla="*/ 567 h 1988"/>
                <a:gd name="T54" fmla="*/ 38 w 38"/>
                <a:gd name="T55" fmla="*/ 573 h 1988"/>
                <a:gd name="T56" fmla="*/ 0 w 38"/>
                <a:gd name="T57" fmla="*/ 573 h 1988"/>
                <a:gd name="T58" fmla="*/ 0 w 38"/>
                <a:gd name="T59" fmla="*/ 567 h 1988"/>
                <a:gd name="T60" fmla="*/ 0 w 38"/>
                <a:gd name="T61" fmla="*/ 284 h 1988"/>
                <a:gd name="T62" fmla="*/ 38 w 38"/>
                <a:gd name="T63" fmla="*/ 284 h 1988"/>
                <a:gd name="T64" fmla="*/ 38 w 38"/>
                <a:gd name="T65" fmla="*/ 289 h 1988"/>
                <a:gd name="T66" fmla="*/ 0 w 38"/>
                <a:gd name="T67" fmla="*/ 289 h 1988"/>
                <a:gd name="T68" fmla="*/ 0 w 38"/>
                <a:gd name="T69" fmla="*/ 284 h 1988"/>
                <a:gd name="T70" fmla="*/ 0 w 38"/>
                <a:gd name="T71" fmla="*/ 0 h 1988"/>
                <a:gd name="T72" fmla="*/ 38 w 38"/>
                <a:gd name="T73" fmla="*/ 0 h 1988"/>
                <a:gd name="T74" fmla="*/ 38 w 38"/>
                <a:gd name="T75" fmla="*/ 6 h 1988"/>
                <a:gd name="T76" fmla="*/ 0 w 38"/>
                <a:gd name="T77" fmla="*/ 6 h 1988"/>
                <a:gd name="T78" fmla="*/ 0 w 38"/>
                <a:gd name="T79" fmla="*/ 0 h 19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38" h="1988">
                  <a:moveTo>
                    <a:pt x="0" y="1983"/>
                  </a:moveTo>
                  <a:lnTo>
                    <a:pt x="38" y="1983"/>
                  </a:lnTo>
                  <a:lnTo>
                    <a:pt x="38" y="1988"/>
                  </a:lnTo>
                  <a:lnTo>
                    <a:pt x="0" y="1988"/>
                  </a:lnTo>
                  <a:lnTo>
                    <a:pt x="0" y="1983"/>
                  </a:lnTo>
                  <a:close/>
                  <a:moveTo>
                    <a:pt x="0" y="1700"/>
                  </a:moveTo>
                  <a:lnTo>
                    <a:pt x="38" y="1700"/>
                  </a:lnTo>
                  <a:lnTo>
                    <a:pt x="38" y="1705"/>
                  </a:lnTo>
                  <a:lnTo>
                    <a:pt x="0" y="1705"/>
                  </a:lnTo>
                  <a:lnTo>
                    <a:pt x="0" y="1700"/>
                  </a:lnTo>
                  <a:close/>
                  <a:moveTo>
                    <a:pt x="0" y="1416"/>
                  </a:moveTo>
                  <a:lnTo>
                    <a:pt x="38" y="1416"/>
                  </a:lnTo>
                  <a:lnTo>
                    <a:pt x="38" y="1422"/>
                  </a:lnTo>
                  <a:lnTo>
                    <a:pt x="0" y="1422"/>
                  </a:lnTo>
                  <a:lnTo>
                    <a:pt x="0" y="1416"/>
                  </a:lnTo>
                  <a:close/>
                  <a:moveTo>
                    <a:pt x="0" y="1133"/>
                  </a:moveTo>
                  <a:lnTo>
                    <a:pt x="38" y="1133"/>
                  </a:lnTo>
                  <a:lnTo>
                    <a:pt x="38" y="1139"/>
                  </a:lnTo>
                  <a:lnTo>
                    <a:pt x="0" y="1139"/>
                  </a:lnTo>
                  <a:lnTo>
                    <a:pt x="0" y="1133"/>
                  </a:lnTo>
                  <a:close/>
                  <a:moveTo>
                    <a:pt x="0" y="850"/>
                  </a:moveTo>
                  <a:lnTo>
                    <a:pt x="38" y="850"/>
                  </a:lnTo>
                  <a:lnTo>
                    <a:pt x="38" y="856"/>
                  </a:lnTo>
                  <a:lnTo>
                    <a:pt x="0" y="856"/>
                  </a:lnTo>
                  <a:lnTo>
                    <a:pt x="0" y="850"/>
                  </a:lnTo>
                  <a:close/>
                  <a:moveTo>
                    <a:pt x="0" y="567"/>
                  </a:moveTo>
                  <a:lnTo>
                    <a:pt x="38" y="567"/>
                  </a:lnTo>
                  <a:lnTo>
                    <a:pt x="38" y="573"/>
                  </a:lnTo>
                  <a:lnTo>
                    <a:pt x="0" y="573"/>
                  </a:lnTo>
                  <a:lnTo>
                    <a:pt x="0" y="567"/>
                  </a:lnTo>
                  <a:close/>
                  <a:moveTo>
                    <a:pt x="0" y="284"/>
                  </a:moveTo>
                  <a:lnTo>
                    <a:pt x="38" y="284"/>
                  </a:lnTo>
                  <a:lnTo>
                    <a:pt x="38" y="289"/>
                  </a:lnTo>
                  <a:lnTo>
                    <a:pt x="0" y="289"/>
                  </a:lnTo>
                  <a:lnTo>
                    <a:pt x="0" y="284"/>
                  </a:lnTo>
                  <a:close/>
                  <a:moveTo>
                    <a:pt x="0" y="0"/>
                  </a:moveTo>
                  <a:lnTo>
                    <a:pt x="38" y="0"/>
                  </a:lnTo>
                  <a:lnTo>
                    <a:pt x="38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1210681" y="2361759"/>
              <a:ext cx="7626212" cy="4587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3"/>
            <p:cNvSpPr>
              <a:spLocks noEditPoints="1"/>
            </p:cNvSpPr>
            <p:nvPr/>
          </p:nvSpPr>
          <p:spPr bwMode="auto">
            <a:xfrm>
              <a:off x="1208373" y="2364512"/>
              <a:ext cx="7630827" cy="35782"/>
            </a:xfrm>
            <a:custGeom>
              <a:avLst/>
              <a:gdLst>
                <a:gd name="T0" fmla="*/ 0 w 9922"/>
                <a:gd name="T1" fmla="*/ 39 h 39"/>
                <a:gd name="T2" fmla="*/ 348 w 9922"/>
                <a:gd name="T3" fmla="*/ 0 h 39"/>
                <a:gd name="T4" fmla="*/ 342 w 9922"/>
                <a:gd name="T5" fmla="*/ 0 h 39"/>
                <a:gd name="T6" fmla="*/ 690 w 9922"/>
                <a:gd name="T7" fmla="*/ 39 h 39"/>
                <a:gd name="T8" fmla="*/ 690 w 9922"/>
                <a:gd name="T9" fmla="*/ 0 h 39"/>
                <a:gd name="T10" fmla="*/ 1026 w 9922"/>
                <a:gd name="T11" fmla="*/ 39 h 39"/>
                <a:gd name="T12" fmla="*/ 1374 w 9922"/>
                <a:gd name="T13" fmla="*/ 0 h 39"/>
                <a:gd name="T14" fmla="*/ 1368 w 9922"/>
                <a:gd name="T15" fmla="*/ 0 h 39"/>
                <a:gd name="T16" fmla="*/ 1716 w 9922"/>
                <a:gd name="T17" fmla="*/ 39 h 39"/>
                <a:gd name="T18" fmla="*/ 1716 w 9922"/>
                <a:gd name="T19" fmla="*/ 0 h 39"/>
                <a:gd name="T20" fmla="*/ 2052 w 9922"/>
                <a:gd name="T21" fmla="*/ 39 h 39"/>
                <a:gd name="T22" fmla="*/ 2400 w 9922"/>
                <a:gd name="T23" fmla="*/ 0 h 39"/>
                <a:gd name="T24" fmla="*/ 2394 w 9922"/>
                <a:gd name="T25" fmla="*/ 0 h 39"/>
                <a:gd name="T26" fmla="*/ 2741 w 9922"/>
                <a:gd name="T27" fmla="*/ 39 h 39"/>
                <a:gd name="T28" fmla="*/ 2741 w 9922"/>
                <a:gd name="T29" fmla="*/ 0 h 39"/>
                <a:gd name="T30" fmla="*/ 3078 w 9922"/>
                <a:gd name="T31" fmla="*/ 39 h 39"/>
                <a:gd name="T32" fmla="*/ 3426 w 9922"/>
                <a:gd name="T33" fmla="*/ 0 h 39"/>
                <a:gd name="T34" fmla="*/ 3420 w 9922"/>
                <a:gd name="T35" fmla="*/ 0 h 39"/>
                <a:gd name="T36" fmla="*/ 3768 w 9922"/>
                <a:gd name="T37" fmla="*/ 39 h 39"/>
                <a:gd name="T38" fmla="*/ 3768 w 9922"/>
                <a:gd name="T39" fmla="*/ 0 h 39"/>
                <a:gd name="T40" fmla="*/ 4104 w 9922"/>
                <a:gd name="T41" fmla="*/ 39 h 39"/>
                <a:gd name="T42" fmla="*/ 4451 w 9922"/>
                <a:gd name="T43" fmla="*/ 0 h 39"/>
                <a:gd name="T44" fmla="*/ 4445 w 9922"/>
                <a:gd name="T45" fmla="*/ 0 h 39"/>
                <a:gd name="T46" fmla="*/ 4793 w 9922"/>
                <a:gd name="T47" fmla="*/ 39 h 39"/>
                <a:gd name="T48" fmla="*/ 4793 w 9922"/>
                <a:gd name="T49" fmla="*/ 0 h 39"/>
                <a:gd name="T50" fmla="*/ 5130 w 9922"/>
                <a:gd name="T51" fmla="*/ 39 h 39"/>
                <a:gd name="T52" fmla="*/ 5477 w 9922"/>
                <a:gd name="T53" fmla="*/ 0 h 39"/>
                <a:gd name="T54" fmla="*/ 5472 w 9922"/>
                <a:gd name="T55" fmla="*/ 0 h 39"/>
                <a:gd name="T56" fmla="*/ 5819 w 9922"/>
                <a:gd name="T57" fmla="*/ 39 h 39"/>
                <a:gd name="T58" fmla="*/ 5819 w 9922"/>
                <a:gd name="T59" fmla="*/ 0 h 39"/>
                <a:gd name="T60" fmla="*/ 6155 w 9922"/>
                <a:gd name="T61" fmla="*/ 39 h 39"/>
                <a:gd name="T62" fmla="*/ 6503 w 9922"/>
                <a:gd name="T63" fmla="*/ 0 h 39"/>
                <a:gd name="T64" fmla="*/ 6497 w 9922"/>
                <a:gd name="T65" fmla="*/ 0 h 39"/>
                <a:gd name="T66" fmla="*/ 6845 w 9922"/>
                <a:gd name="T67" fmla="*/ 39 h 39"/>
                <a:gd name="T68" fmla="*/ 6845 w 9922"/>
                <a:gd name="T69" fmla="*/ 0 h 39"/>
                <a:gd name="T70" fmla="*/ 7181 w 9922"/>
                <a:gd name="T71" fmla="*/ 39 h 39"/>
                <a:gd name="T72" fmla="*/ 7529 w 9922"/>
                <a:gd name="T73" fmla="*/ 0 h 39"/>
                <a:gd name="T74" fmla="*/ 7523 w 9922"/>
                <a:gd name="T75" fmla="*/ 0 h 39"/>
                <a:gd name="T76" fmla="*/ 7871 w 9922"/>
                <a:gd name="T77" fmla="*/ 39 h 39"/>
                <a:gd name="T78" fmla="*/ 7871 w 9922"/>
                <a:gd name="T79" fmla="*/ 0 h 39"/>
                <a:gd name="T80" fmla="*/ 8207 w 9922"/>
                <a:gd name="T81" fmla="*/ 39 h 39"/>
                <a:gd name="T82" fmla="*/ 8554 w 9922"/>
                <a:gd name="T83" fmla="*/ 0 h 39"/>
                <a:gd name="T84" fmla="*/ 8548 w 9922"/>
                <a:gd name="T85" fmla="*/ 0 h 39"/>
                <a:gd name="T86" fmla="*/ 8897 w 9922"/>
                <a:gd name="T87" fmla="*/ 39 h 39"/>
                <a:gd name="T88" fmla="*/ 8897 w 9922"/>
                <a:gd name="T89" fmla="*/ 0 h 39"/>
                <a:gd name="T90" fmla="*/ 9233 w 9922"/>
                <a:gd name="T91" fmla="*/ 39 h 39"/>
                <a:gd name="T92" fmla="*/ 9580 w 9922"/>
                <a:gd name="T93" fmla="*/ 0 h 39"/>
                <a:gd name="T94" fmla="*/ 9575 w 9922"/>
                <a:gd name="T95" fmla="*/ 0 h 39"/>
                <a:gd name="T96" fmla="*/ 9922 w 9922"/>
                <a:gd name="T97" fmla="*/ 39 h 39"/>
                <a:gd name="T98" fmla="*/ 9922 w 9922"/>
                <a:gd name="T99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9922" h="39">
                  <a:moveTo>
                    <a:pt x="6" y="0"/>
                  </a:moveTo>
                  <a:lnTo>
                    <a:pt x="6" y="39"/>
                  </a:lnTo>
                  <a:lnTo>
                    <a:pt x="0" y="39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48" y="0"/>
                  </a:moveTo>
                  <a:lnTo>
                    <a:pt x="348" y="39"/>
                  </a:lnTo>
                  <a:lnTo>
                    <a:pt x="342" y="39"/>
                  </a:lnTo>
                  <a:lnTo>
                    <a:pt x="342" y="0"/>
                  </a:lnTo>
                  <a:lnTo>
                    <a:pt x="348" y="0"/>
                  </a:lnTo>
                  <a:close/>
                  <a:moveTo>
                    <a:pt x="690" y="0"/>
                  </a:moveTo>
                  <a:lnTo>
                    <a:pt x="690" y="39"/>
                  </a:lnTo>
                  <a:lnTo>
                    <a:pt x="684" y="39"/>
                  </a:lnTo>
                  <a:lnTo>
                    <a:pt x="684" y="0"/>
                  </a:lnTo>
                  <a:lnTo>
                    <a:pt x="690" y="0"/>
                  </a:lnTo>
                  <a:close/>
                  <a:moveTo>
                    <a:pt x="1032" y="0"/>
                  </a:moveTo>
                  <a:lnTo>
                    <a:pt x="1032" y="39"/>
                  </a:lnTo>
                  <a:lnTo>
                    <a:pt x="1026" y="39"/>
                  </a:lnTo>
                  <a:lnTo>
                    <a:pt x="1026" y="0"/>
                  </a:lnTo>
                  <a:lnTo>
                    <a:pt x="1032" y="0"/>
                  </a:lnTo>
                  <a:close/>
                  <a:moveTo>
                    <a:pt x="1374" y="0"/>
                  </a:moveTo>
                  <a:lnTo>
                    <a:pt x="1374" y="39"/>
                  </a:lnTo>
                  <a:lnTo>
                    <a:pt x="1368" y="39"/>
                  </a:lnTo>
                  <a:lnTo>
                    <a:pt x="1368" y="0"/>
                  </a:lnTo>
                  <a:lnTo>
                    <a:pt x="1374" y="0"/>
                  </a:lnTo>
                  <a:close/>
                  <a:moveTo>
                    <a:pt x="1716" y="0"/>
                  </a:moveTo>
                  <a:lnTo>
                    <a:pt x="1716" y="39"/>
                  </a:lnTo>
                  <a:lnTo>
                    <a:pt x="1710" y="39"/>
                  </a:lnTo>
                  <a:lnTo>
                    <a:pt x="1710" y="0"/>
                  </a:lnTo>
                  <a:lnTo>
                    <a:pt x="1716" y="0"/>
                  </a:lnTo>
                  <a:close/>
                  <a:moveTo>
                    <a:pt x="2058" y="0"/>
                  </a:moveTo>
                  <a:lnTo>
                    <a:pt x="2058" y="39"/>
                  </a:lnTo>
                  <a:lnTo>
                    <a:pt x="2052" y="39"/>
                  </a:lnTo>
                  <a:lnTo>
                    <a:pt x="2052" y="0"/>
                  </a:lnTo>
                  <a:lnTo>
                    <a:pt x="2058" y="0"/>
                  </a:lnTo>
                  <a:close/>
                  <a:moveTo>
                    <a:pt x="2400" y="0"/>
                  </a:moveTo>
                  <a:lnTo>
                    <a:pt x="2400" y="39"/>
                  </a:lnTo>
                  <a:lnTo>
                    <a:pt x="2394" y="39"/>
                  </a:lnTo>
                  <a:lnTo>
                    <a:pt x="2394" y="0"/>
                  </a:lnTo>
                  <a:lnTo>
                    <a:pt x="2400" y="0"/>
                  </a:lnTo>
                  <a:close/>
                  <a:moveTo>
                    <a:pt x="2741" y="0"/>
                  </a:moveTo>
                  <a:lnTo>
                    <a:pt x="2741" y="39"/>
                  </a:lnTo>
                  <a:lnTo>
                    <a:pt x="2736" y="39"/>
                  </a:lnTo>
                  <a:lnTo>
                    <a:pt x="2736" y="0"/>
                  </a:lnTo>
                  <a:lnTo>
                    <a:pt x="2741" y="0"/>
                  </a:lnTo>
                  <a:close/>
                  <a:moveTo>
                    <a:pt x="3084" y="0"/>
                  </a:moveTo>
                  <a:lnTo>
                    <a:pt x="3084" y="39"/>
                  </a:lnTo>
                  <a:lnTo>
                    <a:pt x="3078" y="39"/>
                  </a:lnTo>
                  <a:lnTo>
                    <a:pt x="3078" y="0"/>
                  </a:lnTo>
                  <a:lnTo>
                    <a:pt x="3084" y="0"/>
                  </a:lnTo>
                  <a:close/>
                  <a:moveTo>
                    <a:pt x="3426" y="0"/>
                  </a:moveTo>
                  <a:lnTo>
                    <a:pt x="3426" y="39"/>
                  </a:lnTo>
                  <a:lnTo>
                    <a:pt x="3420" y="39"/>
                  </a:lnTo>
                  <a:lnTo>
                    <a:pt x="3420" y="0"/>
                  </a:lnTo>
                  <a:lnTo>
                    <a:pt x="3426" y="0"/>
                  </a:lnTo>
                  <a:close/>
                  <a:moveTo>
                    <a:pt x="3768" y="0"/>
                  </a:moveTo>
                  <a:lnTo>
                    <a:pt x="3768" y="39"/>
                  </a:lnTo>
                  <a:lnTo>
                    <a:pt x="3762" y="39"/>
                  </a:lnTo>
                  <a:lnTo>
                    <a:pt x="3762" y="0"/>
                  </a:lnTo>
                  <a:lnTo>
                    <a:pt x="3768" y="0"/>
                  </a:lnTo>
                  <a:close/>
                  <a:moveTo>
                    <a:pt x="4109" y="0"/>
                  </a:moveTo>
                  <a:lnTo>
                    <a:pt x="4109" y="39"/>
                  </a:lnTo>
                  <a:lnTo>
                    <a:pt x="4104" y="39"/>
                  </a:lnTo>
                  <a:lnTo>
                    <a:pt x="4104" y="0"/>
                  </a:lnTo>
                  <a:lnTo>
                    <a:pt x="4109" y="0"/>
                  </a:lnTo>
                  <a:close/>
                  <a:moveTo>
                    <a:pt x="4451" y="0"/>
                  </a:moveTo>
                  <a:lnTo>
                    <a:pt x="4451" y="39"/>
                  </a:lnTo>
                  <a:lnTo>
                    <a:pt x="4445" y="39"/>
                  </a:lnTo>
                  <a:lnTo>
                    <a:pt x="4445" y="0"/>
                  </a:lnTo>
                  <a:lnTo>
                    <a:pt x="4451" y="0"/>
                  </a:lnTo>
                  <a:close/>
                  <a:moveTo>
                    <a:pt x="4793" y="0"/>
                  </a:moveTo>
                  <a:lnTo>
                    <a:pt x="4793" y="39"/>
                  </a:lnTo>
                  <a:lnTo>
                    <a:pt x="4787" y="39"/>
                  </a:lnTo>
                  <a:lnTo>
                    <a:pt x="4787" y="0"/>
                  </a:lnTo>
                  <a:lnTo>
                    <a:pt x="4793" y="0"/>
                  </a:lnTo>
                  <a:close/>
                  <a:moveTo>
                    <a:pt x="5136" y="0"/>
                  </a:moveTo>
                  <a:lnTo>
                    <a:pt x="5136" y="39"/>
                  </a:lnTo>
                  <a:lnTo>
                    <a:pt x="5130" y="39"/>
                  </a:lnTo>
                  <a:lnTo>
                    <a:pt x="5130" y="0"/>
                  </a:lnTo>
                  <a:lnTo>
                    <a:pt x="5136" y="0"/>
                  </a:lnTo>
                  <a:close/>
                  <a:moveTo>
                    <a:pt x="5477" y="0"/>
                  </a:moveTo>
                  <a:lnTo>
                    <a:pt x="5477" y="39"/>
                  </a:lnTo>
                  <a:lnTo>
                    <a:pt x="5472" y="39"/>
                  </a:lnTo>
                  <a:lnTo>
                    <a:pt x="5472" y="0"/>
                  </a:lnTo>
                  <a:lnTo>
                    <a:pt x="5477" y="0"/>
                  </a:lnTo>
                  <a:close/>
                  <a:moveTo>
                    <a:pt x="5819" y="0"/>
                  </a:moveTo>
                  <a:lnTo>
                    <a:pt x="5819" y="39"/>
                  </a:lnTo>
                  <a:lnTo>
                    <a:pt x="5813" y="39"/>
                  </a:lnTo>
                  <a:lnTo>
                    <a:pt x="5813" y="0"/>
                  </a:lnTo>
                  <a:lnTo>
                    <a:pt x="5819" y="0"/>
                  </a:lnTo>
                  <a:close/>
                  <a:moveTo>
                    <a:pt x="6161" y="0"/>
                  </a:moveTo>
                  <a:lnTo>
                    <a:pt x="6161" y="39"/>
                  </a:lnTo>
                  <a:lnTo>
                    <a:pt x="6155" y="39"/>
                  </a:lnTo>
                  <a:lnTo>
                    <a:pt x="6155" y="0"/>
                  </a:lnTo>
                  <a:lnTo>
                    <a:pt x="6161" y="0"/>
                  </a:lnTo>
                  <a:close/>
                  <a:moveTo>
                    <a:pt x="6503" y="0"/>
                  </a:moveTo>
                  <a:lnTo>
                    <a:pt x="6503" y="39"/>
                  </a:lnTo>
                  <a:lnTo>
                    <a:pt x="6497" y="39"/>
                  </a:lnTo>
                  <a:lnTo>
                    <a:pt x="6497" y="0"/>
                  </a:lnTo>
                  <a:lnTo>
                    <a:pt x="6503" y="0"/>
                  </a:lnTo>
                  <a:close/>
                  <a:moveTo>
                    <a:pt x="6845" y="0"/>
                  </a:moveTo>
                  <a:lnTo>
                    <a:pt x="6845" y="39"/>
                  </a:lnTo>
                  <a:lnTo>
                    <a:pt x="6840" y="39"/>
                  </a:lnTo>
                  <a:lnTo>
                    <a:pt x="6840" y="0"/>
                  </a:lnTo>
                  <a:lnTo>
                    <a:pt x="6845" y="0"/>
                  </a:lnTo>
                  <a:close/>
                  <a:moveTo>
                    <a:pt x="7187" y="0"/>
                  </a:moveTo>
                  <a:lnTo>
                    <a:pt x="7187" y="39"/>
                  </a:lnTo>
                  <a:lnTo>
                    <a:pt x="7181" y="39"/>
                  </a:lnTo>
                  <a:lnTo>
                    <a:pt x="7181" y="0"/>
                  </a:lnTo>
                  <a:lnTo>
                    <a:pt x="7187" y="0"/>
                  </a:lnTo>
                  <a:close/>
                  <a:moveTo>
                    <a:pt x="7529" y="0"/>
                  </a:moveTo>
                  <a:lnTo>
                    <a:pt x="7529" y="39"/>
                  </a:lnTo>
                  <a:lnTo>
                    <a:pt x="7523" y="39"/>
                  </a:lnTo>
                  <a:lnTo>
                    <a:pt x="7523" y="0"/>
                  </a:lnTo>
                  <a:lnTo>
                    <a:pt x="7529" y="0"/>
                  </a:lnTo>
                  <a:close/>
                  <a:moveTo>
                    <a:pt x="7871" y="0"/>
                  </a:moveTo>
                  <a:lnTo>
                    <a:pt x="7871" y="39"/>
                  </a:lnTo>
                  <a:lnTo>
                    <a:pt x="7865" y="39"/>
                  </a:lnTo>
                  <a:lnTo>
                    <a:pt x="7865" y="0"/>
                  </a:lnTo>
                  <a:lnTo>
                    <a:pt x="7871" y="0"/>
                  </a:lnTo>
                  <a:close/>
                  <a:moveTo>
                    <a:pt x="8212" y="0"/>
                  </a:moveTo>
                  <a:lnTo>
                    <a:pt x="8212" y="39"/>
                  </a:lnTo>
                  <a:lnTo>
                    <a:pt x="8207" y="39"/>
                  </a:lnTo>
                  <a:lnTo>
                    <a:pt x="8207" y="0"/>
                  </a:lnTo>
                  <a:lnTo>
                    <a:pt x="8212" y="0"/>
                  </a:lnTo>
                  <a:close/>
                  <a:moveTo>
                    <a:pt x="8554" y="0"/>
                  </a:moveTo>
                  <a:lnTo>
                    <a:pt x="8554" y="39"/>
                  </a:lnTo>
                  <a:lnTo>
                    <a:pt x="8548" y="39"/>
                  </a:lnTo>
                  <a:lnTo>
                    <a:pt x="8548" y="0"/>
                  </a:lnTo>
                  <a:lnTo>
                    <a:pt x="8554" y="0"/>
                  </a:lnTo>
                  <a:close/>
                  <a:moveTo>
                    <a:pt x="8897" y="0"/>
                  </a:moveTo>
                  <a:lnTo>
                    <a:pt x="8897" y="39"/>
                  </a:lnTo>
                  <a:lnTo>
                    <a:pt x="8891" y="39"/>
                  </a:lnTo>
                  <a:lnTo>
                    <a:pt x="8891" y="0"/>
                  </a:lnTo>
                  <a:lnTo>
                    <a:pt x="8897" y="0"/>
                  </a:lnTo>
                  <a:close/>
                  <a:moveTo>
                    <a:pt x="9239" y="0"/>
                  </a:moveTo>
                  <a:lnTo>
                    <a:pt x="9239" y="39"/>
                  </a:lnTo>
                  <a:lnTo>
                    <a:pt x="9233" y="39"/>
                  </a:lnTo>
                  <a:lnTo>
                    <a:pt x="9233" y="0"/>
                  </a:lnTo>
                  <a:lnTo>
                    <a:pt x="9239" y="0"/>
                  </a:lnTo>
                  <a:close/>
                  <a:moveTo>
                    <a:pt x="9580" y="0"/>
                  </a:moveTo>
                  <a:lnTo>
                    <a:pt x="9580" y="39"/>
                  </a:lnTo>
                  <a:lnTo>
                    <a:pt x="9575" y="39"/>
                  </a:lnTo>
                  <a:lnTo>
                    <a:pt x="9575" y="0"/>
                  </a:lnTo>
                  <a:lnTo>
                    <a:pt x="9580" y="0"/>
                  </a:lnTo>
                  <a:close/>
                  <a:moveTo>
                    <a:pt x="9922" y="0"/>
                  </a:moveTo>
                  <a:lnTo>
                    <a:pt x="9922" y="39"/>
                  </a:lnTo>
                  <a:lnTo>
                    <a:pt x="9916" y="39"/>
                  </a:lnTo>
                  <a:lnTo>
                    <a:pt x="9916" y="0"/>
                  </a:lnTo>
                  <a:lnTo>
                    <a:pt x="9922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482678" y="2002273"/>
              <a:ext cx="599901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4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482678" y="1741712"/>
              <a:ext cx="599901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8,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381000" y="1482069"/>
              <a:ext cx="701579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2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381000" y="1222425"/>
              <a:ext cx="701579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6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9"/>
            <p:cNvSpPr>
              <a:spLocks noChangeArrowheads="1"/>
            </p:cNvSpPr>
            <p:nvPr/>
          </p:nvSpPr>
          <p:spPr bwMode="auto">
            <a:xfrm>
              <a:off x="381000" y="962782"/>
              <a:ext cx="701579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381000" y="703139"/>
              <a:ext cx="701579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4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21"/>
            <p:cNvSpPr>
              <a:spLocks noChangeArrowheads="1"/>
            </p:cNvSpPr>
            <p:nvPr/>
          </p:nvSpPr>
          <p:spPr bwMode="auto">
            <a:xfrm>
              <a:off x="381000" y="442578"/>
              <a:ext cx="701579" cy="269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8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76200" y="152400"/>
              <a:ext cx="8915400" cy="6533696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76200" y="4419600"/>
              <a:ext cx="8915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3367751" y="4142601"/>
              <a:ext cx="3109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HLA DQ Single Antigen beads specificiti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190"/>
            <p:cNvSpPr>
              <a:spLocks noChangeArrowheads="1"/>
            </p:cNvSpPr>
            <p:nvPr/>
          </p:nvSpPr>
          <p:spPr bwMode="auto">
            <a:xfrm>
              <a:off x="2442944" y="196357"/>
              <a:ext cx="45969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QB </a:t>
              </a:r>
              <a:r>
                <a:rPr kumimoji="0" lang="en-US" sz="1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pitope</a:t>
              </a: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on DQB4,5,6,8,9 chains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 62"/>
            <p:cNvGrpSpPr/>
            <p:nvPr/>
          </p:nvGrpSpPr>
          <p:grpSpPr>
            <a:xfrm>
              <a:off x="1245460" y="3259439"/>
              <a:ext cx="7593740" cy="884742"/>
              <a:chOff x="1372028" y="2482533"/>
              <a:chExt cx="7228618" cy="890074"/>
            </a:xfrm>
          </p:grpSpPr>
          <p:sp>
            <p:nvSpPr>
              <p:cNvPr id="96" name="Rectangle 799"/>
              <p:cNvSpPr>
                <a:spLocks noChangeArrowheads="1"/>
              </p:cNvSpPr>
              <p:nvPr/>
            </p:nvSpPr>
            <p:spPr bwMode="auto">
              <a:xfrm rot="16200000">
                <a:off x="1011492" y="2843181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801"/>
              <p:cNvSpPr>
                <a:spLocks noChangeArrowheads="1"/>
              </p:cNvSpPr>
              <p:nvPr/>
            </p:nvSpPr>
            <p:spPr bwMode="auto">
              <a:xfrm rot="16200000">
                <a:off x="1263907" y="2843183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ctangle 803"/>
              <p:cNvSpPr>
                <a:spLocks noChangeArrowheads="1"/>
              </p:cNvSpPr>
              <p:nvPr/>
            </p:nvSpPr>
            <p:spPr bwMode="auto">
              <a:xfrm rot="16200000">
                <a:off x="1516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ctangle 805"/>
              <p:cNvSpPr>
                <a:spLocks noChangeArrowheads="1"/>
              </p:cNvSpPr>
              <p:nvPr/>
            </p:nvSpPr>
            <p:spPr bwMode="auto">
              <a:xfrm rot="16200000">
                <a:off x="1770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ctangle 807"/>
              <p:cNvSpPr>
                <a:spLocks noChangeArrowheads="1"/>
              </p:cNvSpPr>
              <p:nvPr/>
            </p:nvSpPr>
            <p:spPr bwMode="auto">
              <a:xfrm rot="16200000">
                <a:off x="2021145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ctangle 809"/>
              <p:cNvSpPr>
                <a:spLocks noChangeArrowheads="1"/>
              </p:cNvSpPr>
              <p:nvPr/>
            </p:nvSpPr>
            <p:spPr bwMode="auto">
              <a:xfrm rot="16200000">
                <a:off x="2273559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ctangle 811"/>
              <p:cNvSpPr>
                <a:spLocks noChangeArrowheads="1"/>
              </p:cNvSpPr>
              <p:nvPr/>
            </p:nvSpPr>
            <p:spPr bwMode="auto">
              <a:xfrm rot="16200000">
                <a:off x="2525969" y="2844657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Rectangle 813"/>
              <p:cNvSpPr>
                <a:spLocks noChangeArrowheads="1"/>
              </p:cNvSpPr>
              <p:nvPr/>
            </p:nvSpPr>
            <p:spPr bwMode="auto">
              <a:xfrm rot="16200000">
                <a:off x="2778382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ctangle 815"/>
              <p:cNvSpPr>
                <a:spLocks noChangeArrowheads="1"/>
              </p:cNvSpPr>
              <p:nvPr/>
            </p:nvSpPr>
            <p:spPr bwMode="auto">
              <a:xfrm rot="16200000">
                <a:off x="3030795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817"/>
              <p:cNvSpPr>
                <a:spLocks noChangeArrowheads="1"/>
              </p:cNvSpPr>
              <p:nvPr/>
            </p:nvSpPr>
            <p:spPr bwMode="auto">
              <a:xfrm rot="16200000">
                <a:off x="3281620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Rectangle 819"/>
              <p:cNvSpPr>
                <a:spLocks noChangeArrowheads="1"/>
              </p:cNvSpPr>
              <p:nvPr/>
            </p:nvSpPr>
            <p:spPr bwMode="auto">
              <a:xfrm rot="16200000">
                <a:off x="3534032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Rectangle 821"/>
              <p:cNvSpPr>
                <a:spLocks noChangeArrowheads="1"/>
              </p:cNvSpPr>
              <p:nvPr/>
            </p:nvSpPr>
            <p:spPr bwMode="auto">
              <a:xfrm rot="16200000">
                <a:off x="3786446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Rectangle 823"/>
              <p:cNvSpPr>
                <a:spLocks noChangeArrowheads="1"/>
              </p:cNvSpPr>
              <p:nvPr/>
            </p:nvSpPr>
            <p:spPr bwMode="auto">
              <a:xfrm rot="16200000">
                <a:off x="4038860" y="2843069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825"/>
              <p:cNvSpPr>
                <a:spLocks noChangeArrowheads="1"/>
              </p:cNvSpPr>
              <p:nvPr/>
            </p:nvSpPr>
            <p:spPr bwMode="auto">
              <a:xfrm rot="16200000">
                <a:off x="429127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827"/>
              <p:cNvSpPr>
                <a:spLocks noChangeArrowheads="1"/>
              </p:cNvSpPr>
              <p:nvPr/>
            </p:nvSpPr>
            <p:spPr bwMode="auto">
              <a:xfrm rot="16200000">
                <a:off x="4542097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829"/>
              <p:cNvSpPr>
                <a:spLocks noChangeArrowheads="1"/>
              </p:cNvSpPr>
              <p:nvPr/>
            </p:nvSpPr>
            <p:spPr bwMode="auto">
              <a:xfrm rot="16200000">
                <a:off x="479450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831"/>
              <p:cNvSpPr>
                <a:spLocks noChangeArrowheads="1"/>
              </p:cNvSpPr>
              <p:nvPr/>
            </p:nvSpPr>
            <p:spPr bwMode="auto">
              <a:xfrm rot="16200000">
                <a:off x="5046922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833"/>
              <p:cNvSpPr>
                <a:spLocks noChangeArrowheads="1"/>
              </p:cNvSpPr>
              <p:nvPr/>
            </p:nvSpPr>
            <p:spPr bwMode="auto">
              <a:xfrm rot="16200000">
                <a:off x="52977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835"/>
              <p:cNvSpPr>
                <a:spLocks noChangeArrowheads="1"/>
              </p:cNvSpPr>
              <p:nvPr/>
            </p:nvSpPr>
            <p:spPr bwMode="auto">
              <a:xfrm rot="16200000">
                <a:off x="55517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837"/>
              <p:cNvSpPr>
                <a:spLocks noChangeArrowheads="1"/>
              </p:cNvSpPr>
              <p:nvPr/>
            </p:nvSpPr>
            <p:spPr bwMode="auto">
              <a:xfrm rot="16200000">
                <a:off x="580257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Rectangle 839"/>
              <p:cNvSpPr>
                <a:spLocks noChangeArrowheads="1"/>
              </p:cNvSpPr>
              <p:nvPr/>
            </p:nvSpPr>
            <p:spPr bwMode="auto">
              <a:xfrm rot="16200000">
                <a:off x="6054984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5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841"/>
              <p:cNvSpPr>
                <a:spLocks noChangeArrowheads="1"/>
              </p:cNvSpPr>
              <p:nvPr/>
            </p:nvSpPr>
            <p:spPr bwMode="auto">
              <a:xfrm rot="16200000">
                <a:off x="6307397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6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Rectangle 843"/>
              <p:cNvSpPr>
                <a:spLocks noChangeArrowheads="1"/>
              </p:cNvSpPr>
              <p:nvPr/>
            </p:nvSpPr>
            <p:spPr bwMode="auto">
              <a:xfrm rot="16200000">
                <a:off x="655980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845"/>
              <p:cNvSpPr>
                <a:spLocks noChangeArrowheads="1"/>
              </p:cNvSpPr>
              <p:nvPr/>
            </p:nvSpPr>
            <p:spPr bwMode="auto">
              <a:xfrm rot="16200000">
                <a:off x="6812221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847"/>
              <p:cNvSpPr>
                <a:spLocks noChangeArrowheads="1"/>
              </p:cNvSpPr>
              <p:nvPr/>
            </p:nvSpPr>
            <p:spPr bwMode="auto">
              <a:xfrm rot="16200000">
                <a:off x="7063045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849"/>
              <p:cNvSpPr>
                <a:spLocks noChangeArrowheads="1"/>
              </p:cNvSpPr>
              <p:nvPr/>
            </p:nvSpPr>
            <p:spPr bwMode="auto">
              <a:xfrm rot="16200000">
                <a:off x="731545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851"/>
              <p:cNvSpPr>
                <a:spLocks noChangeArrowheads="1"/>
              </p:cNvSpPr>
              <p:nvPr/>
            </p:nvSpPr>
            <p:spPr bwMode="auto">
              <a:xfrm rot="16200000">
                <a:off x="7567869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853"/>
              <p:cNvSpPr>
                <a:spLocks noChangeArrowheads="1"/>
              </p:cNvSpPr>
              <p:nvPr/>
            </p:nvSpPr>
            <p:spPr bwMode="auto">
              <a:xfrm rot="16200000">
                <a:off x="7820284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855"/>
              <p:cNvSpPr>
                <a:spLocks noChangeArrowheads="1"/>
              </p:cNvSpPr>
              <p:nvPr/>
            </p:nvSpPr>
            <p:spPr bwMode="auto">
              <a:xfrm rot="16200000">
                <a:off x="8072696" y="284465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63"/>
            <p:cNvGrpSpPr/>
            <p:nvPr/>
          </p:nvGrpSpPr>
          <p:grpSpPr>
            <a:xfrm>
              <a:off x="1236909" y="2362200"/>
              <a:ext cx="7583934" cy="921282"/>
              <a:chOff x="1497834" y="2957398"/>
              <a:chExt cx="7219282" cy="783686"/>
            </a:xfrm>
          </p:grpSpPr>
          <p:sp>
            <p:nvSpPr>
              <p:cNvPr id="67" name="Rectangle 800"/>
              <p:cNvSpPr>
                <a:spLocks noChangeArrowheads="1"/>
              </p:cNvSpPr>
              <p:nvPr/>
            </p:nvSpPr>
            <p:spPr bwMode="auto">
              <a:xfrm rot="16200000">
                <a:off x="1228906" y="3306016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68" name="Rectangle 802"/>
              <p:cNvSpPr>
                <a:spLocks noChangeArrowheads="1"/>
              </p:cNvSpPr>
              <p:nvPr/>
            </p:nvSpPr>
            <p:spPr bwMode="auto">
              <a:xfrm rot="16200000">
                <a:off x="1481318" y="3306015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2</a:t>
                </a:r>
              </a:p>
            </p:txBody>
          </p:sp>
          <p:sp>
            <p:nvSpPr>
              <p:cNvPr id="69" name="Rectangle 804"/>
              <p:cNvSpPr>
                <a:spLocks noChangeArrowheads="1"/>
              </p:cNvSpPr>
              <p:nvPr/>
            </p:nvSpPr>
            <p:spPr bwMode="auto">
              <a:xfrm rot="16200000">
                <a:off x="1733732" y="3306015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70" name="Rectangle 806"/>
              <p:cNvSpPr>
                <a:spLocks noChangeArrowheads="1"/>
              </p:cNvSpPr>
              <p:nvPr/>
            </p:nvSpPr>
            <p:spPr bwMode="auto">
              <a:xfrm rot="16200000">
                <a:off x="1986142" y="3306015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  <a:endParaRPr lang="en-US" sz="11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808"/>
              <p:cNvSpPr>
                <a:spLocks noChangeArrowheads="1"/>
              </p:cNvSpPr>
              <p:nvPr/>
            </p:nvSpPr>
            <p:spPr bwMode="auto">
              <a:xfrm rot="16200000">
                <a:off x="2238556" y="3306015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2:01</a:t>
                </a:r>
              </a:p>
            </p:txBody>
          </p:sp>
          <p:sp>
            <p:nvSpPr>
              <p:cNvPr id="72" name="Rectangle 810"/>
              <p:cNvSpPr>
                <a:spLocks noChangeArrowheads="1"/>
              </p:cNvSpPr>
              <p:nvPr/>
            </p:nvSpPr>
            <p:spPr bwMode="auto">
              <a:xfrm rot="16200000">
                <a:off x="2490966" y="3306018"/>
                <a:ext cx="698140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1</a:t>
                </a:r>
              </a:p>
            </p:txBody>
          </p:sp>
          <p:sp>
            <p:nvSpPr>
              <p:cNvPr id="73" name="Rectangle 812"/>
              <p:cNvSpPr>
                <a:spLocks noChangeArrowheads="1"/>
              </p:cNvSpPr>
              <p:nvPr/>
            </p:nvSpPr>
            <p:spPr bwMode="auto">
              <a:xfrm rot="16200000">
                <a:off x="2743381" y="3304433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74" name="Rectangle 814"/>
              <p:cNvSpPr>
                <a:spLocks noChangeArrowheads="1"/>
              </p:cNvSpPr>
              <p:nvPr/>
            </p:nvSpPr>
            <p:spPr bwMode="auto">
              <a:xfrm rot="16200000">
                <a:off x="2994206" y="3304433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1</a:t>
                </a:r>
              </a:p>
            </p:txBody>
          </p:sp>
          <p:sp>
            <p:nvSpPr>
              <p:cNvPr id="75" name="Rectangle 816"/>
              <p:cNvSpPr>
                <a:spLocks noChangeArrowheads="1"/>
              </p:cNvSpPr>
              <p:nvPr/>
            </p:nvSpPr>
            <p:spPr bwMode="auto">
              <a:xfrm rot="16200000">
                <a:off x="3246619" y="3304433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76" name="Rectangle 818"/>
              <p:cNvSpPr>
                <a:spLocks noChangeArrowheads="1"/>
              </p:cNvSpPr>
              <p:nvPr/>
            </p:nvSpPr>
            <p:spPr bwMode="auto">
              <a:xfrm rot="16200000">
                <a:off x="3504478" y="3311036"/>
                <a:ext cx="687249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1</a:t>
                </a:r>
              </a:p>
            </p:txBody>
          </p:sp>
          <p:sp>
            <p:nvSpPr>
              <p:cNvPr id="77" name="Rectangle 820"/>
              <p:cNvSpPr>
                <a:spLocks noChangeArrowheads="1"/>
              </p:cNvSpPr>
              <p:nvPr/>
            </p:nvSpPr>
            <p:spPr bwMode="auto">
              <a:xfrm rot="16200000">
                <a:off x="3756889" y="3298735"/>
                <a:ext cx="687249" cy="161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2</a:t>
                </a:r>
              </a:p>
            </p:txBody>
          </p:sp>
          <p:sp>
            <p:nvSpPr>
              <p:cNvPr id="78" name="Rectangle 822"/>
              <p:cNvSpPr>
                <a:spLocks noChangeArrowheads="1"/>
              </p:cNvSpPr>
              <p:nvPr/>
            </p:nvSpPr>
            <p:spPr bwMode="auto">
              <a:xfrm rot="16200000">
                <a:off x="4003856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79" name="Rectangle 824"/>
              <p:cNvSpPr>
                <a:spLocks noChangeArrowheads="1"/>
              </p:cNvSpPr>
              <p:nvPr/>
            </p:nvSpPr>
            <p:spPr bwMode="auto">
              <a:xfrm rot="16200000">
                <a:off x="4254682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80" name="Rectangle 826"/>
              <p:cNvSpPr>
                <a:spLocks noChangeArrowheads="1"/>
              </p:cNvSpPr>
              <p:nvPr/>
            </p:nvSpPr>
            <p:spPr bwMode="auto">
              <a:xfrm rot="16200000">
                <a:off x="4507095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4</a:t>
                </a:r>
              </a:p>
            </p:txBody>
          </p:sp>
          <p:sp>
            <p:nvSpPr>
              <p:cNvPr id="81" name="Rectangle 828"/>
              <p:cNvSpPr>
                <a:spLocks noChangeArrowheads="1"/>
              </p:cNvSpPr>
              <p:nvPr/>
            </p:nvSpPr>
            <p:spPr bwMode="auto">
              <a:xfrm rot="16200000">
                <a:off x="4759507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9</a:t>
                </a:r>
              </a:p>
            </p:txBody>
          </p:sp>
          <p:sp>
            <p:nvSpPr>
              <p:cNvPr id="82" name="Rectangle 830"/>
              <p:cNvSpPr>
                <a:spLocks noChangeArrowheads="1"/>
              </p:cNvSpPr>
              <p:nvPr/>
            </p:nvSpPr>
            <p:spPr bwMode="auto">
              <a:xfrm rot="16200000">
                <a:off x="5011919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1</a:t>
                </a:r>
              </a:p>
            </p:txBody>
          </p:sp>
          <p:sp>
            <p:nvSpPr>
              <p:cNvPr id="83" name="Rectangle 832"/>
              <p:cNvSpPr>
                <a:spLocks noChangeArrowheads="1"/>
              </p:cNvSpPr>
              <p:nvPr/>
            </p:nvSpPr>
            <p:spPr bwMode="auto">
              <a:xfrm rot="16200000">
                <a:off x="5264329" y="3304920"/>
                <a:ext cx="698141" cy="160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3</a:t>
                </a:r>
              </a:p>
            </p:txBody>
          </p:sp>
          <p:sp>
            <p:nvSpPr>
              <p:cNvPr id="84" name="Rectangle 834"/>
              <p:cNvSpPr>
                <a:spLocks noChangeArrowheads="1"/>
              </p:cNvSpPr>
              <p:nvPr/>
            </p:nvSpPr>
            <p:spPr bwMode="auto">
              <a:xfrm rot="16200000">
                <a:off x="5525830" y="3317854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85" name="Rectangle 836"/>
              <p:cNvSpPr>
                <a:spLocks noChangeArrowheads="1"/>
              </p:cNvSpPr>
              <p:nvPr/>
            </p:nvSpPr>
            <p:spPr bwMode="auto">
              <a:xfrm rot="16200000">
                <a:off x="5779830" y="3317854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86" name="Rectangle 838"/>
              <p:cNvSpPr>
                <a:spLocks noChangeArrowheads="1"/>
              </p:cNvSpPr>
              <p:nvPr/>
            </p:nvSpPr>
            <p:spPr bwMode="auto">
              <a:xfrm rot="16200000">
                <a:off x="6032245" y="3317854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87" name="Rectangle 840"/>
              <p:cNvSpPr>
                <a:spLocks noChangeArrowheads="1"/>
              </p:cNvSpPr>
              <p:nvPr/>
            </p:nvSpPr>
            <p:spPr bwMode="auto">
              <a:xfrm rot="16200000">
                <a:off x="6284656" y="3317854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88" name="Rectangle 842"/>
              <p:cNvSpPr>
                <a:spLocks noChangeArrowheads="1"/>
              </p:cNvSpPr>
              <p:nvPr/>
            </p:nvSpPr>
            <p:spPr bwMode="auto">
              <a:xfrm rot="16200000">
                <a:off x="6537070" y="3317854"/>
                <a:ext cx="673613" cy="161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89" name="Rectangle 844"/>
              <p:cNvSpPr>
                <a:spLocks noChangeArrowheads="1"/>
              </p:cNvSpPr>
              <p:nvPr/>
            </p:nvSpPr>
            <p:spPr bwMode="auto">
              <a:xfrm rot="16200000">
                <a:off x="6732860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90" name="Rectangle 846"/>
              <p:cNvSpPr>
                <a:spLocks noChangeArrowheads="1"/>
              </p:cNvSpPr>
              <p:nvPr/>
            </p:nvSpPr>
            <p:spPr bwMode="auto">
              <a:xfrm rot="16200000">
                <a:off x="6985269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91" name="Rectangle 848"/>
              <p:cNvSpPr>
                <a:spLocks noChangeArrowheads="1"/>
              </p:cNvSpPr>
              <p:nvPr/>
            </p:nvSpPr>
            <p:spPr bwMode="auto">
              <a:xfrm rot="16200000">
                <a:off x="7237683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92" name="Rectangle 850"/>
              <p:cNvSpPr>
                <a:spLocks noChangeArrowheads="1"/>
              </p:cNvSpPr>
              <p:nvPr/>
            </p:nvSpPr>
            <p:spPr bwMode="auto">
              <a:xfrm rot="16200000">
                <a:off x="7490095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93" name="Rectangle 852"/>
              <p:cNvSpPr>
                <a:spLocks noChangeArrowheads="1"/>
              </p:cNvSpPr>
              <p:nvPr/>
            </p:nvSpPr>
            <p:spPr bwMode="auto">
              <a:xfrm rot="16200000">
                <a:off x="7742509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94" name="Rectangle 854"/>
              <p:cNvSpPr>
                <a:spLocks noChangeArrowheads="1"/>
              </p:cNvSpPr>
              <p:nvPr/>
            </p:nvSpPr>
            <p:spPr bwMode="auto">
              <a:xfrm rot="16200000">
                <a:off x="7993333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95" name="Rectangle 856"/>
              <p:cNvSpPr>
                <a:spLocks noChangeArrowheads="1"/>
              </p:cNvSpPr>
              <p:nvPr/>
            </p:nvSpPr>
            <p:spPr bwMode="auto">
              <a:xfrm rot="16200000">
                <a:off x="8245746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606503" y="2581785"/>
              <a:ext cx="571578" cy="596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Bet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81016" y="3403966"/>
              <a:ext cx="598225" cy="596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lph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16"/>
            <p:cNvSpPr>
              <a:spLocks noChangeArrowheads="1"/>
            </p:cNvSpPr>
            <p:nvPr/>
          </p:nvSpPr>
          <p:spPr bwMode="auto">
            <a:xfrm>
              <a:off x="517758" y="2209800"/>
              <a:ext cx="65003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,000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01" name="Picture 5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00" y="4499434"/>
              <a:ext cx="4043732" cy="21299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Group 128"/>
            <p:cNvGrpSpPr/>
            <p:nvPr/>
          </p:nvGrpSpPr>
          <p:grpSpPr>
            <a:xfrm>
              <a:off x="5954602" y="4415545"/>
              <a:ext cx="1365730" cy="2248359"/>
              <a:chOff x="7244870" y="4415545"/>
              <a:chExt cx="1365730" cy="2248359"/>
            </a:xfrm>
          </p:grpSpPr>
          <p:pic>
            <p:nvPicPr>
              <p:cNvPr id="39" name="Picture 3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33983" t="9442" r="37069" b="1"/>
              <a:stretch/>
            </p:blipFill>
            <p:spPr>
              <a:xfrm>
                <a:off x="7244870" y="4454104"/>
                <a:ext cx="1365730" cy="2209800"/>
              </a:xfrm>
              <a:prstGeom prst="rect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</p:pic>
          <p:sp>
            <p:nvSpPr>
              <p:cNvPr id="145" name="TextBox 144"/>
              <p:cNvSpPr txBox="1"/>
              <p:nvPr/>
            </p:nvSpPr>
            <p:spPr>
              <a:xfrm>
                <a:off x="7613571" y="4415545"/>
                <a:ext cx="762804" cy="2425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Peptide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7406309" y="5403012"/>
                <a:ext cx="442291" cy="3119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eta</a:t>
                </a:r>
              </a:p>
              <a:p>
                <a:pPr algn="ctr"/>
                <a:r>
                  <a:rPr lang="en-US" sz="11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1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7373790" y="5133201"/>
                <a:ext cx="474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45G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8" name="Straight Arrow Connector 147"/>
              <p:cNvCxnSpPr/>
              <p:nvPr/>
            </p:nvCxnSpPr>
            <p:spPr>
              <a:xfrm flipH="1">
                <a:off x="7864127" y="4596459"/>
                <a:ext cx="59282" cy="131162"/>
              </a:xfrm>
              <a:prstGeom prst="straightConnector1">
                <a:avLst/>
              </a:prstGeom>
              <a:ln w="3175"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9" name="TextBox 148"/>
              <p:cNvSpPr txBox="1"/>
              <p:nvPr/>
            </p:nvSpPr>
            <p:spPr>
              <a:xfrm>
                <a:off x="7848600" y="5334000"/>
                <a:ext cx="546945" cy="43088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Alpha</a:t>
                </a:r>
              </a:p>
              <a:p>
                <a:pPr algn="ctr"/>
                <a:r>
                  <a:rPr lang="en-US" sz="11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1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>
                <a:off x="7772424" y="4870102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46V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5" name="Rectangle 111"/>
            <p:cNvSpPr>
              <a:spLocks noChangeArrowheads="1"/>
            </p:cNvSpPr>
            <p:nvPr/>
          </p:nvSpPr>
          <p:spPr bwMode="auto">
            <a:xfrm>
              <a:off x="1338167" y="640216"/>
              <a:ext cx="101600" cy="10160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 rot="16200000">
              <a:off x="-976517" y="1277930"/>
              <a:ext cx="2451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Fluorescence Intensity (MFI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74711"/>
            <a:ext cx="866730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L.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2010 shared by the beta chains of DQ antigens DQ4, 5, 6, 8, 9 and defined by 45G+46V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713930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2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31:25Z</dcterms:created>
  <dcterms:modified xsi:type="dcterms:W3CDTF">2017-03-12T04:32:44Z</dcterms:modified>
</cp:coreProperties>
</file>